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0"/>
  </p:notesMasterIdLst>
  <p:sldIdLst>
    <p:sldId id="256" r:id="rId2"/>
    <p:sldId id="258" r:id="rId3"/>
    <p:sldId id="259" r:id="rId4"/>
    <p:sldId id="260" r:id="rId5"/>
    <p:sldId id="261" r:id="rId6"/>
    <p:sldId id="262" r:id="rId7"/>
    <p:sldId id="264" r:id="rId8"/>
    <p:sldId id="263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84286"/>
  </p:normalViewPr>
  <p:slideViewPr>
    <p:cSldViewPr snapToGrid="0">
      <p:cViewPr varScale="1">
        <p:scale>
          <a:sx n="104" d="100"/>
          <a:sy n="104" d="100"/>
        </p:scale>
        <p:origin x="232" y="2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F27DF6-796F-2245-B470-00E41E106252}" type="datetimeFigureOut">
              <a:rPr lang="en-US" smtClean="0"/>
              <a:t>4/12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A31D78-1ABA-D74E-B85E-6B54DDC2E1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79854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commons.wikimedia.org/wiki/File:RVOT_Tachycardia.png" TargetMode="External"/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3" Type="http://schemas.openxmlformats.org/officeDocument/2006/relationships/hyperlink" Target="https://commons.wikimedia.org/wiki/File:Enfermedad_Mitral.JPG" TargetMode="External"/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#1 Electrocardiogram # 1 –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Ventricular tachycardia</a:t>
            </a:r>
            <a:b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</a:b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Ksheka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t English Wikipedia. RVOT Tachycardia. In: Wikimedia Commons. </a:t>
            </a:r>
            <a:r>
              <a:rPr lang="en-US" sz="1800" u="sng" dirty="0">
                <a:solidFill>
                  <a:srgbClr val="0563C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hlinkClick r:id="rId3"/>
              </a:rPr>
              <a:t>https://commons.wikimedia.org/wiki/File:RVOT_Tachycardia.png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CC BY-SA 3.0 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A31D78-1ABA-D74E-B85E-6B54DDC2E1B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29664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#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2 CXR –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XR with cardiomegaly </a:t>
            </a:r>
          </a:p>
          <a:p>
            <a:pPr marL="0" marR="0">
              <a:spcBef>
                <a:spcPts val="0"/>
              </a:spcBef>
              <a:spcAft>
                <a:spcPts val="300"/>
              </a:spcAft>
            </a:pPr>
            <a:r>
              <a:rPr lang="en-US" sz="1800" b="0" dirty="0" err="1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Times New Roman" panose="02020603050405020304" pitchFamily="18" charset="0"/>
              </a:rPr>
              <a:t>SCiardullo</a:t>
            </a:r>
            <a:r>
              <a:rPr lang="en-US" sz="1800" b="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800" b="0" dirty="0" err="1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Times New Roman" panose="02020603050405020304" pitchFamily="18" charset="0"/>
              </a:rPr>
              <a:t>Enfermedad</a:t>
            </a:r>
            <a:r>
              <a:rPr lang="en-US" sz="1800" b="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Times New Roman" panose="02020603050405020304" pitchFamily="18" charset="0"/>
              </a:rPr>
              <a:t> Mitral In: Wikimedia Commons. </a:t>
            </a:r>
            <a:r>
              <a:rPr lang="en-US" sz="1800" b="0" u="sng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Times New Roman" panose="02020603050405020304" pitchFamily="18" charset="0"/>
                <a:hlinkClick r:id="rId3"/>
              </a:rPr>
              <a:t>https://commons.wikimedia.org/wiki/File:Enfermedad_Mitral.JPG</a:t>
            </a:r>
            <a:r>
              <a:rPr lang="en-US" sz="1800" b="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Times New Roman" panose="02020603050405020304" pitchFamily="18" charset="0"/>
              </a:rPr>
              <a:t>. CC BY-SA 3.0</a:t>
            </a:r>
            <a:endParaRPr lang="en-US" sz="1800" b="1" dirty="0">
              <a:effectLst/>
              <a:highlight>
                <a:srgbClr val="FFFFFF"/>
              </a:highlight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A31D78-1ABA-D74E-B85E-6B54DDC2E1B9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275117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# 3 Electrocardiogram # 2: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ost-ROSC ECG showing LBBB that meets the Modified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garbossa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Criteria for a STEMI equivalent 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mage source: Courtesy of Kelsey Keeling, DO 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A31D78-1ABA-D74E-B85E-6B54DDC2E1B9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763350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# 4 Complete blood count (CBC)</a:t>
            </a:r>
            <a:r>
              <a:rPr lang="en-US" dirty="0">
                <a:effectLst/>
              </a:rPr>
              <a:t>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A31D78-1ABA-D74E-B85E-6B54DDC2E1B9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626066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#5	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omplete Metabolic Panel (CMP)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A31D78-1ABA-D74E-B85E-6B54DDC2E1B9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645191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# 6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roponin</a:t>
            </a:r>
            <a:r>
              <a:rPr lang="en-US" dirty="0">
                <a:effectLst/>
              </a:rPr>
              <a:t>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A31D78-1ABA-D74E-B85E-6B54DDC2E1B9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571591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#7	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actic acid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	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A31D78-1ABA-D74E-B85E-6B54DDC2E1B9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2778520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# </a:t>
            </a:r>
            <a:r>
              <a:rPr lang="en-US"/>
              <a:t>8 </a:t>
            </a:r>
            <a:r>
              <a:rPr lang="en-US" sz="180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agnesium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	1.3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Eq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/L</a:t>
            </a:r>
            <a:r>
              <a:rPr lang="en-US" dirty="0">
                <a:effectLst/>
              </a:rPr>
              <a:t>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A31D78-1ABA-D74E-B85E-6B54DDC2E1B9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57039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601B7E-0A6B-E062-7663-97EA40F9C45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4C432A7-34ED-2834-46D9-FF07B85FCAC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F086FD-3D42-C7AF-27CC-A68625AA21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8B64C-652D-474A-84CA-D50F0D6BC314}" type="datetimeFigureOut">
              <a:rPr lang="en-US" smtClean="0"/>
              <a:t>4/1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BB8192-0EA9-09EA-F56D-D9E5D1B021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936EEC-18D8-FEAA-3EDB-8BBAFB7BDA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FCA0C-181C-9942-B729-39CCA0B85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39605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163EB7-9D16-CCCB-2DBD-A7D3EA2313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F8186A-115C-18AA-76EC-0EDF706C61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847ECA-3A66-12E9-4C03-7482CC9987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8B64C-652D-474A-84CA-D50F0D6BC314}" type="datetimeFigureOut">
              <a:rPr lang="en-US" smtClean="0"/>
              <a:t>4/1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FB1F43-6AC0-93B7-612C-3A985B4B65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126A79-4F74-0045-460D-A855039E04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FCA0C-181C-9942-B729-39CCA0B85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18972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D743F53-AFCF-0C9A-D9D5-926C497B307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B4CB10F-883B-9380-55AD-4211DEBA21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3AF6CF-8CD9-B588-3977-92FD7719EA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8B64C-652D-474A-84CA-D50F0D6BC314}" type="datetimeFigureOut">
              <a:rPr lang="en-US" smtClean="0"/>
              <a:t>4/1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38AAC5-0CA0-75C8-F652-DF602B3D20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ACAF07-BC50-2624-1B81-95E29C1250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FCA0C-181C-9942-B729-39CCA0B85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66222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1E4B96-0DFB-A735-4660-6F6EE62AEC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085F8D6-9EB8-9316-38C6-BB4A890F797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B7C46F-8BCA-0C8E-E33C-9118468F46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8B64C-652D-474A-84CA-D50F0D6BC314}" type="datetimeFigureOut">
              <a:rPr lang="en-US" smtClean="0"/>
              <a:t>4/1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3A45EF-E0CE-04DA-2F27-B9887DF105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63B967-30CA-A8CF-98B3-73C1B041D9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FCA0C-181C-9942-B729-39CCA0B85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04175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3BA343-84E0-7593-51C7-03A95B01FF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3A9DD0-5BB5-1969-DF57-2058EC1C18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C34A29-3896-D292-52CE-3DA146E962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8B64C-652D-474A-84CA-D50F0D6BC314}" type="datetimeFigureOut">
              <a:rPr lang="en-US" smtClean="0"/>
              <a:t>4/1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36B9FD-B638-6E39-2306-F9FFA1E07F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526E27-98D9-0CA6-D3C5-F53BC86156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FCA0C-181C-9942-B729-39CCA0B85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57228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D6DCE3-68DB-C0CA-BC8E-F8055185D0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A08513D-7E6C-37E1-F359-9DE97DCC374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2B82D4C-07BB-4FE1-18BA-FBFE8A44D1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A034AC-711B-E66B-B8E9-8E91CAEB56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8B64C-652D-474A-84CA-D50F0D6BC314}" type="datetimeFigureOut">
              <a:rPr lang="en-US" smtClean="0"/>
              <a:t>4/12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F6531A-64DE-E732-5EF0-3087D125E8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F378C17-F040-FE02-AE49-DB59EBC8DF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FCA0C-181C-9942-B729-39CCA0B85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83292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1988FE-959F-1E67-2432-5E9D7A225A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E699B77-5551-B1E3-ED82-B058EB8A95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C8D7880-045B-4E4D-6527-2136B32A48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DCDC767-C493-3924-9A7F-EBA54B046F9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DD4A15B-12EA-D9FA-01B0-5FEF08B9162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A5206BF-9892-2797-BBE0-6B46F0B780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8B64C-652D-474A-84CA-D50F0D6BC314}" type="datetimeFigureOut">
              <a:rPr lang="en-US" smtClean="0"/>
              <a:t>4/12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5BB9FF2-BCD9-410E-E5CC-BD25615F15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CDDD569-C0EC-7FF6-CBC5-78EC961FC8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FCA0C-181C-9942-B729-39CCA0B85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587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22E543-C8BD-AC0A-A876-03DD04F395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790F9F6-9831-4887-45DE-50BBBB4CE1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8B64C-652D-474A-84CA-D50F0D6BC314}" type="datetimeFigureOut">
              <a:rPr lang="en-US" smtClean="0"/>
              <a:t>4/12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53CD376-7EDC-4E86-DBD5-69A205AEEB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92A0589-C7B2-787E-4B0E-329ADAFC46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FCA0C-181C-9942-B729-39CCA0B85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41745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8451F2E-D2D5-3E38-B9A7-FD0AAB6741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8B64C-652D-474A-84CA-D50F0D6BC314}" type="datetimeFigureOut">
              <a:rPr lang="en-US" smtClean="0"/>
              <a:t>4/12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8C1A094-0CA0-5467-4C7C-9A5FAC1CE5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43C543F-6D55-5E25-B6E5-012B3A89A9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FCA0C-181C-9942-B729-39CCA0B85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68549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4366E9-E37D-389B-B69C-AAB604359D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354EC47-9E9D-1195-3AE5-BF7AA179F47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1214AFD-DE61-4B66-1DCA-E84B5D1D73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94A9E37-D5A7-6613-8114-B9E1BD9709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8B64C-652D-474A-84CA-D50F0D6BC314}" type="datetimeFigureOut">
              <a:rPr lang="en-US" smtClean="0"/>
              <a:t>4/12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8F09E4-0A64-403F-F057-34EAF4D2D6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680663-B665-834B-4755-9EE553EF75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FCA0C-181C-9942-B729-39CCA0B85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66332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9EB2FA-33F7-4674-C0E0-6454031979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9FAB712-B239-762F-9D73-E5D7AB01410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EFF6AE6-B8C9-9C68-01FB-84A9E693B1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94D879-A262-3507-80E4-0B50D3CFF7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8B64C-652D-474A-84CA-D50F0D6BC314}" type="datetimeFigureOut">
              <a:rPr lang="en-US" smtClean="0"/>
              <a:t>4/12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5A1C80-E901-754B-EE6B-F75BFC8962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2E867D2-981A-27B4-1A63-7BCC086E3F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FCA0C-181C-9942-B729-39CCA0B85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90778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F7B86E4-8904-FDE1-15F4-3E49F7DE71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65FEE88-FC6A-1498-1451-530D577DD9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4BF9D3-48CC-A91F-06AB-4580B34E4BF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618B64C-652D-474A-84CA-D50F0D6BC314}" type="datetimeFigureOut">
              <a:rPr lang="en-US" smtClean="0"/>
              <a:t>4/1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90C0E6-E0F4-490A-E55A-F9061367267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D2C9C5-8AF5-B2F2-B3F2-C60753A341B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83FCA0C-181C-9942-B729-39CCA0B85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54204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https://upload.wikimedia.org/wikipedia/commons/5/59/RVOT_Tachycardia.png?20071107195109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https://upload.wikimedia.org/wikipedia/commons/thumb/f/fb/Enfermedad_Mitral.JPG/717px-Enfermedad_Mitral.JPG?20140227143348" TargetMode="Externa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568C2010-2208-A4B5-69CD-B57A7A25FBB3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902523"/>
            <a:ext cx="19682589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1025" name="Picture 7" descr="File:RVOT Tachycardia.png">
            <a:extLst>
              <a:ext uri="{FF2B5EF4-FFF2-40B4-BE49-F238E27FC236}">
                <a16:creationId xmlns:a16="http://schemas.microsoft.com/office/drawing/2014/main" id="{08EF25B8-9585-9703-94E8-FD2083E921B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r:link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902524"/>
            <a:ext cx="12190977" cy="48451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6106254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ACE00F92-AD16-725B-AC59-73EDA5FAFA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93076" y="0"/>
            <a:ext cx="25828246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2049" name="Picture 14" descr="File:Enfermedad Mitral.JPG">
            <a:extLst>
              <a:ext uri="{FF2B5EF4-FFF2-40B4-BE49-F238E27FC236}">
                <a16:creationId xmlns:a16="http://schemas.microsoft.com/office/drawing/2014/main" id="{7F4F7102-C5FF-1BF3-72E4-D1C5F0A0E51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r:link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93075" y="1"/>
            <a:ext cx="8205849" cy="686062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984924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0102A77-58F6-8A61-9A9C-DA845E74B7E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sharpenSoften amount="6000"/>
                    </a14:imgEffect>
                    <a14:imgEffect>
                      <a14:colorTemperature colorTemp="9138"/>
                    </a14:imgEffect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2727" t="11165" r="4562" b="16388"/>
          <a:stretch/>
        </p:blipFill>
        <p:spPr bwMode="auto">
          <a:xfrm>
            <a:off x="244982" y="0"/>
            <a:ext cx="11702035" cy="685800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30682196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5117049-7684-AB98-24E2-7F37852D4E28}"/>
              </a:ext>
            </a:extLst>
          </p:cNvPr>
          <p:cNvSpPr txBox="1"/>
          <p:nvPr/>
        </p:nvSpPr>
        <p:spPr>
          <a:xfrm>
            <a:off x="1612075" y="432851"/>
            <a:ext cx="609797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omplete blood count (CBC)</a:t>
            </a:r>
            <a:r>
              <a:rPr lang="en-US" dirty="0">
                <a:effectLst/>
              </a:rPr>
              <a:t> </a:t>
            </a:r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53E9359-7253-1CFB-F9C7-7C85994BB81B}"/>
              </a:ext>
            </a:extLst>
          </p:cNvPr>
          <p:cNvSpPr txBox="1"/>
          <p:nvPr/>
        </p:nvSpPr>
        <p:spPr>
          <a:xfrm>
            <a:off x="3048990" y="2043031"/>
            <a:ext cx="7282542" cy="222387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457200" marR="0" indent="45720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White blood count (WBC) 	13.3 x1000/mm3</a:t>
            </a:r>
          </a:p>
          <a:p>
            <a:pPr marL="457200" marR="0" indent="45720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Hemoglobin (Hgb) 		12.7 g/dL</a:t>
            </a:r>
          </a:p>
          <a:p>
            <a:pPr marL="457200" marR="0" indent="45720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Hematocrit (HCT) 		35.7%</a:t>
            </a:r>
          </a:p>
          <a:p>
            <a:pPr marL="457200" marR="0" indent="45720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latelet (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lt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		348 x1000/mm3</a:t>
            </a:r>
          </a:p>
        </p:txBody>
      </p:sp>
    </p:spTree>
    <p:extLst>
      <p:ext uri="{BB962C8B-B14F-4D97-AF65-F5344CB8AC3E}">
        <p14:creationId xmlns:p14="http://schemas.microsoft.com/office/powerpoint/2010/main" val="42379875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0EE59E4-122E-6A4B-D60C-8AC9CED9AD03}"/>
              </a:ext>
            </a:extLst>
          </p:cNvPr>
          <p:cNvSpPr txBox="1"/>
          <p:nvPr/>
        </p:nvSpPr>
        <p:spPr>
          <a:xfrm>
            <a:off x="1160814" y="551604"/>
            <a:ext cx="609797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omplete Metabolic Panel (CMP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59AA0B4-2310-86AE-135D-4A9417FBD2DF}"/>
              </a:ext>
            </a:extLst>
          </p:cNvPr>
          <p:cNvSpPr txBox="1"/>
          <p:nvPr/>
        </p:nvSpPr>
        <p:spPr>
          <a:xfrm>
            <a:off x="3048990" y="1212034"/>
            <a:ext cx="7246916" cy="44398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457200" marR="0" indent="45720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odium 			140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Eq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/L</a:t>
            </a:r>
          </a:p>
          <a:p>
            <a:pPr marL="457200" marR="0" indent="45720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hloride 			102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Eq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/L</a:t>
            </a:r>
          </a:p>
          <a:p>
            <a:pPr marL="457200" marR="0" indent="45720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otassium 		3.9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Eq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/L</a:t>
            </a:r>
          </a:p>
          <a:p>
            <a:pPr marL="457200" marR="0" indent="45720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icarbonate (HCO3)	24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Eq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/L</a:t>
            </a:r>
          </a:p>
          <a:p>
            <a:pPr marL="457200" marR="0" indent="45720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lood Urea Nitrogen (BUN)	 51 mg/dL</a:t>
            </a:r>
          </a:p>
          <a:p>
            <a:pPr marL="457200" marR="0" indent="45720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reatine (Cr)		0.71 mg/dL</a:t>
            </a:r>
          </a:p>
          <a:p>
            <a:pPr marL="457200" marR="0" indent="45720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Glucose 			177 mg/dL</a:t>
            </a:r>
          </a:p>
          <a:p>
            <a:pPr marL="457200" marR="0" indent="45720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alcium 			8.7 mg/dL</a:t>
            </a:r>
          </a:p>
        </p:txBody>
      </p:sp>
    </p:spTree>
    <p:extLst>
      <p:ext uri="{BB962C8B-B14F-4D97-AF65-F5344CB8AC3E}">
        <p14:creationId xmlns:p14="http://schemas.microsoft.com/office/powerpoint/2010/main" val="190724963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D18AF8F1-EBEC-BB92-61A0-978BF2DD0127}"/>
              </a:ext>
            </a:extLst>
          </p:cNvPr>
          <p:cNvSpPr txBox="1"/>
          <p:nvPr/>
        </p:nvSpPr>
        <p:spPr>
          <a:xfrm>
            <a:off x="3049030" y="3244334"/>
            <a:ext cx="609805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roponin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	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	32 ng/L</a:t>
            </a:r>
            <a:r>
              <a:rPr lang="en-US" dirty="0">
                <a:effectLst/>
              </a:rPr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7035641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086F560-545A-F61F-6E8C-371A9F58B7B6}"/>
              </a:ext>
            </a:extLst>
          </p:cNvPr>
          <p:cNvSpPr txBox="1"/>
          <p:nvPr/>
        </p:nvSpPr>
        <p:spPr>
          <a:xfrm>
            <a:off x="3049030" y="3148026"/>
            <a:ext cx="6098058" cy="56194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actic acid		3.9 mmol/L</a:t>
            </a:r>
          </a:p>
        </p:txBody>
      </p:sp>
    </p:spTree>
    <p:extLst>
      <p:ext uri="{BB962C8B-B14F-4D97-AF65-F5344CB8AC3E}">
        <p14:creationId xmlns:p14="http://schemas.microsoft.com/office/powerpoint/2010/main" val="190783354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283C423-A229-F3CC-66E2-9293016285D4}"/>
              </a:ext>
            </a:extLst>
          </p:cNvPr>
          <p:cNvSpPr txBox="1"/>
          <p:nvPr/>
        </p:nvSpPr>
        <p:spPr>
          <a:xfrm>
            <a:off x="3049030" y="3244334"/>
            <a:ext cx="609805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agnesium		1.3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Eq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/L</a:t>
            </a:r>
            <a:r>
              <a:rPr lang="en-US" dirty="0">
                <a:effectLst/>
              </a:rPr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099040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294</Words>
  <Application>Microsoft Macintosh PowerPoint</Application>
  <PresentationFormat>Widescreen</PresentationFormat>
  <Paragraphs>35</Paragraphs>
  <Slides>8</Slides>
  <Notes>8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ohey, Shannon</dc:creator>
  <cp:lastModifiedBy>Toohey, Shannon</cp:lastModifiedBy>
  <cp:revision>2</cp:revision>
  <dcterms:created xsi:type="dcterms:W3CDTF">2024-04-12T17:56:45Z</dcterms:created>
  <dcterms:modified xsi:type="dcterms:W3CDTF">2024-04-12T18:03:09Z</dcterms:modified>
</cp:coreProperties>
</file>